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3282" y="-198"/>
      </p:cViewPr>
      <p:guideLst>
        <p:guide orient="horz" pos="3905"/>
        <p:guide pos="1162"/>
        <p:guide pos="37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007769-E21E-4396-B33B-AFF17428045E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1F31D7-2E09-496B-B854-B701C975E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6726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1F31D7-2E09-496B-B854-B701C975EEA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64651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9482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4180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472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9958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9400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9965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0996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0228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1146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1716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979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89AC00-91EB-4F3A-BF79-05E57622142B}" type="datetimeFigureOut">
              <a:rPr lang="de-DE" smtClean="0"/>
              <a:t>05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DB3E9-7650-404F-8F7C-777DEE51B80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0325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uppieren 23"/>
          <p:cNvGrpSpPr/>
          <p:nvPr/>
        </p:nvGrpSpPr>
        <p:grpSpPr>
          <a:xfrm>
            <a:off x="549280" y="5752572"/>
            <a:ext cx="5417965" cy="2563844"/>
            <a:chOff x="549280" y="5508104"/>
            <a:chExt cx="5417965" cy="2563844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9280" y="5508104"/>
              <a:ext cx="5400000" cy="2397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" name="Gruppieren 4"/>
            <p:cNvGrpSpPr/>
            <p:nvPr/>
          </p:nvGrpSpPr>
          <p:grpSpPr>
            <a:xfrm>
              <a:off x="1218207" y="7524328"/>
              <a:ext cx="4749038" cy="215444"/>
              <a:chOff x="1218207" y="7524328"/>
              <a:chExt cx="4749038" cy="215444"/>
            </a:xfrm>
          </p:grpSpPr>
          <p:sp>
            <p:nvSpPr>
              <p:cNvPr id="4" name="Textfeld 3"/>
              <p:cNvSpPr txBox="1"/>
              <p:nvPr/>
            </p:nvSpPr>
            <p:spPr>
              <a:xfrm>
                <a:off x="1218207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feld 7"/>
              <p:cNvSpPr txBox="1"/>
              <p:nvPr/>
            </p:nvSpPr>
            <p:spPr>
              <a:xfrm>
                <a:off x="2574992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3943144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5311296" y="7524328"/>
                <a:ext cx="6559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Textfeld 21"/>
            <p:cNvSpPr txBox="1"/>
            <p:nvPr/>
          </p:nvSpPr>
          <p:spPr>
            <a:xfrm>
              <a:off x="1218207" y="5580112"/>
              <a:ext cx="465871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rboplatin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Gruppieren 22"/>
            <p:cNvGrpSpPr/>
            <p:nvPr/>
          </p:nvGrpSpPr>
          <p:grpSpPr>
            <a:xfrm>
              <a:off x="1268760" y="7733394"/>
              <a:ext cx="4536504" cy="338554"/>
              <a:chOff x="1268760" y="7733394"/>
              <a:chExt cx="4536504" cy="338554"/>
            </a:xfrm>
          </p:grpSpPr>
          <p:sp>
            <p:nvSpPr>
              <p:cNvPr id="6" name="Textfeld 5"/>
              <p:cNvSpPr txBox="1"/>
              <p:nvPr/>
            </p:nvSpPr>
            <p:spPr>
              <a:xfrm>
                <a:off x="1268760" y="7733394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20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1889337" y="77333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474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>
                <a:off x="2567622" y="7733394"/>
                <a:ext cx="5677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BL100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3319645" y="7733394"/>
                <a:ext cx="463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CF7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3953045" y="7733394"/>
                <a:ext cx="5453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-</a:t>
                </a:r>
              </a:p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231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4653772" y="7733394"/>
                <a:ext cx="5453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-</a:t>
                </a:r>
              </a:p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468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5368926" y="7733394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47D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9" name="Gruppieren 38"/>
          <p:cNvGrpSpPr/>
          <p:nvPr/>
        </p:nvGrpSpPr>
        <p:grpSpPr>
          <a:xfrm>
            <a:off x="439382" y="3158463"/>
            <a:ext cx="5509897" cy="2544179"/>
            <a:chOff x="439382" y="3158463"/>
            <a:chExt cx="5509897" cy="254417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9382" y="3158463"/>
              <a:ext cx="5509897" cy="23428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7" name="Gruppieren 16"/>
            <p:cNvGrpSpPr/>
            <p:nvPr/>
          </p:nvGrpSpPr>
          <p:grpSpPr>
            <a:xfrm>
              <a:off x="1196752" y="5148064"/>
              <a:ext cx="4749038" cy="215444"/>
              <a:chOff x="1218207" y="7524328"/>
              <a:chExt cx="4749038" cy="215444"/>
            </a:xfrm>
          </p:grpSpPr>
          <p:sp>
            <p:nvSpPr>
              <p:cNvPr id="18" name="Textfeld 17"/>
              <p:cNvSpPr txBox="1"/>
              <p:nvPr/>
            </p:nvSpPr>
            <p:spPr>
              <a:xfrm>
                <a:off x="1218207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>
                <a:off x="2574992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>
                <a:off x="3943144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>
                <a:off x="5311296" y="7524328"/>
                <a:ext cx="6559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" name="Textfeld 30"/>
            <p:cNvSpPr txBox="1"/>
            <p:nvPr/>
          </p:nvSpPr>
          <p:spPr>
            <a:xfrm>
              <a:off x="1196752" y="3203848"/>
              <a:ext cx="465871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clitaxe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Gruppieren 39"/>
            <p:cNvGrpSpPr/>
            <p:nvPr/>
          </p:nvGrpSpPr>
          <p:grpSpPr>
            <a:xfrm>
              <a:off x="1268760" y="5364088"/>
              <a:ext cx="4536504" cy="338554"/>
              <a:chOff x="1268760" y="7733394"/>
              <a:chExt cx="4536504" cy="338554"/>
            </a:xfrm>
          </p:grpSpPr>
          <p:sp>
            <p:nvSpPr>
              <p:cNvPr id="41" name="Textfeld 40"/>
              <p:cNvSpPr txBox="1"/>
              <p:nvPr/>
            </p:nvSpPr>
            <p:spPr>
              <a:xfrm>
                <a:off x="1268760" y="7733394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20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feld 41"/>
              <p:cNvSpPr txBox="1"/>
              <p:nvPr/>
            </p:nvSpPr>
            <p:spPr>
              <a:xfrm>
                <a:off x="1889337" y="77333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474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2567622" y="7733394"/>
                <a:ext cx="5677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BL100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3319645" y="7733394"/>
                <a:ext cx="463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CF7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3953045" y="7733394"/>
                <a:ext cx="5453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-</a:t>
                </a:r>
              </a:p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231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4653772" y="7733394"/>
                <a:ext cx="5453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-</a:t>
                </a:r>
              </a:p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468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5368926" y="7733394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47D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0" name="Gruppieren 29"/>
          <p:cNvGrpSpPr/>
          <p:nvPr/>
        </p:nvGrpSpPr>
        <p:grpSpPr>
          <a:xfrm>
            <a:off x="477272" y="683568"/>
            <a:ext cx="5468518" cy="2457625"/>
            <a:chOff x="477272" y="868753"/>
            <a:chExt cx="5468518" cy="24576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7272" y="868753"/>
              <a:ext cx="5468518" cy="21910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2" name="Gruppieren 11"/>
            <p:cNvGrpSpPr/>
            <p:nvPr/>
          </p:nvGrpSpPr>
          <p:grpSpPr>
            <a:xfrm>
              <a:off x="1196752" y="2843808"/>
              <a:ext cx="4749038" cy="215444"/>
              <a:chOff x="1218207" y="7524328"/>
              <a:chExt cx="4749038" cy="215444"/>
            </a:xfrm>
          </p:grpSpPr>
          <p:sp>
            <p:nvSpPr>
              <p:cNvPr id="13" name="Textfeld 12"/>
              <p:cNvSpPr txBox="1"/>
              <p:nvPr/>
            </p:nvSpPr>
            <p:spPr>
              <a:xfrm>
                <a:off x="1218207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>
                <a:off x="2574992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3943144" y="7524328"/>
                <a:ext cx="13580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       5% 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5311296" y="7524328"/>
                <a:ext cx="6559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%    21%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Textfeld 31"/>
            <p:cNvSpPr txBox="1"/>
            <p:nvPr/>
          </p:nvSpPr>
          <p:spPr>
            <a:xfrm>
              <a:off x="1196752" y="910625"/>
              <a:ext cx="465871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pirubicin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" name="Gruppieren 47"/>
            <p:cNvGrpSpPr/>
            <p:nvPr/>
          </p:nvGrpSpPr>
          <p:grpSpPr>
            <a:xfrm>
              <a:off x="1268760" y="2987824"/>
              <a:ext cx="4536504" cy="338554"/>
              <a:chOff x="1268760" y="7733394"/>
              <a:chExt cx="4536504" cy="338554"/>
            </a:xfrm>
          </p:grpSpPr>
          <p:sp>
            <p:nvSpPr>
              <p:cNvPr id="49" name="Textfeld 48"/>
              <p:cNvSpPr txBox="1"/>
              <p:nvPr/>
            </p:nvSpPr>
            <p:spPr>
              <a:xfrm>
                <a:off x="1268760" y="7733394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20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feld 49"/>
              <p:cNvSpPr txBox="1"/>
              <p:nvPr/>
            </p:nvSpPr>
            <p:spPr>
              <a:xfrm>
                <a:off x="1889337" y="7733394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T474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2567622" y="7733394"/>
                <a:ext cx="5677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BL100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3319645" y="7733394"/>
                <a:ext cx="463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CF7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3953045" y="7733394"/>
                <a:ext cx="5453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-</a:t>
                </a:r>
              </a:p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231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feld 53"/>
              <p:cNvSpPr txBox="1"/>
              <p:nvPr/>
            </p:nvSpPr>
            <p:spPr>
              <a:xfrm>
                <a:off x="4653772" y="7733394"/>
                <a:ext cx="5453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DA-</a:t>
                </a:r>
              </a:p>
              <a:p>
                <a:pPr algn="ctr"/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468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5368926" y="7733394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47D</a:t>
                </a:r>
                <a:endParaRPr lang="de-DE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7" name="Gruppieren 56"/>
          <p:cNvGrpSpPr/>
          <p:nvPr/>
        </p:nvGrpSpPr>
        <p:grpSpPr>
          <a:xfrm>
            <a:off x="1835893" y="6199188"/>
            <a:ext cx="3465315" cy="2116428"/>
            <a:chOff x="1835893" y="6199188"/>
            <a:chExt cx="3465315" cy="2116428"/>
          </a:xfrm>
        </p:grpSpPr>
        <p:cxnSp>
          <p:nvCxnSpPr>
            <p:cNvPr id="11" name="Gerade Verbindung 10"/>
            <p:cNvCxnSpPr/>
            <p:nvPr/>
          </p:nvCxnSpPr>
          <p:spPr>
            <a:xfrm flipV="1">
              <a:off x="1835893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Gerade Verbindung 59"/>
            <p:cNvCxnSpPr/>
            <p:nvPr/>
          </p:nvCxnSpPr>
          <p:spPr>
            <a:xfrm flipV="1">
              <a:off x="2528956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Gerade Verbindung 60"/>
            <p:cNvCxnSpPr/>
            <p:nvPr/>
          </p:nvCxnSpPr>
          <p:spPr>
            <a:xfrm flipV="1">
              <a:off x="3222019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Gerade Verbindung 61"/>
            <p:cNvCxnSpPr/>
            <p:nvPr/>
          </p:nvCxnSpPr>
          <p:spPr>
            <a:xfrm flipV="1">
              <a:off x="3915082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Gerade Verbindung 62"/>
            <p:cNvCxnSpPr/>
            <p:nvPr/>
          </p:nvCxnSpPr>
          <p:spPr>
            <a:xfrm flipV="1">
              <a:off x="4608145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Gerade Verbindung 63"/>
            <p:cNvCxnSpPr/>
            <p:nvPr/>
          </p:nvCxnSpPr>
          <p:spPr>
            <a:xfrm flipV="1">
              <a:off x="5301208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Gruppieren 65"/>
          <p:cNvGrpSpPr/>
          <p:nvPr/>
        </p:nvGrpSpPr>
        <p:grpSpPr>
          <a:xfrm>
            <a:off x="1844824" y="3563888"/>
            <a:ext cx="3465315" cy="2116428"/>
            <a:chOff x="1835893" y="6199188"/>
            <a:chExt cx="3465315" cy="2116428"/>
          </a:xfrm>
        </p:grpSpPr>
        <p:cxnSp>
          <p:nvCxnSpPr>
            <p:cNvPr id="67" name="Gerade Verbindung 66"/>
            <p:cNvCxnSpPr/>
            <p:nvPr/>
          </p:nvCxnSpPr>
          <p:spPr>
            <a:xfrm flipV="1">
              <a:off x="1835893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Gerade Verbindung 67"/>
            <p:cNvCxnSpPr/>
            <p:nvPr/>
          </p:nvCxnSpPr>
          <p:spPr>
            <a:xfrm flipV="1">
              <a:off x="2528956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Gerade Verbindung 68"/>
            <p:cNvCxnSpPr/>
            <p:nvPr/>
          </p:nvCxnSpPr>
          <p:spPr>
            <a:xfrm flipV="1">
              <a:off x="3222019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Gerade Verbindung 69"/>
            <p:cNvCxnSpPr/>
            <p:nvPr/>
          </p:nvCxnSpPr>
          <p:spPr>
            <a:xfrm flipV="1">
              <a:off x="3915082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 Verbindung 70"/>
            <p:cNvCxnSpPr/>
            <p:nvPr/>
          </p:nvCxnSpPr>
          <p:spPr>
            <a:xfrm flipV="1">
              <a:off x="4608145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Gerade Verbindung 71"/>
            <p:cNvCxnSpPr/>
            <p:nvPr/>
          </p:nvCxnSpPr>
          <p:spPr>
            <a:xfrm flipV="1">
              <a:off x="5301208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uppieren 72"/>
          <p:cNvGrpSpPr/>
          <p:nvPr/>
        </p:nvGrpSpPr>
        <p:grpSpPr>
          <a:xfrm>
            <a:off x="1844824" y="1087420"/>
            <a:ext cx="3465315" cy="2116428"/>
            <a:chOff x="1835893" y="6199188"/>
            <a:chExt cx="3465315" cy="2116428"/>
          </a:xfrm>
        </p:grpSpPr>
        <p:cxnSp>
          <p:nvCxnSpPr>
            <p:cNvPr id="74" name="Gerade Verbindung 73"/>
            <p:cNvCxnSpPr/>
            <p:nvPr/>
          </p:nvCxnSpPr>
          <p:spPr>
            <a:xfrm flipV="1">
              <a:off x="1835893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Gerade Verbindung 74"/>
            <p:cNvCxnSpPr/>
            <p:nvPr/>
          </p:nvCxnSpPr>
          <p:spPr>
            <a:xfrm flipV="1">
              <a:off x="2528956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Gerade Verbindung 75"/>
            <p:cNvCxnSpPr/>
            <p:nvPr/>
          </p:nvCxnSpPr>
          <p:spPr>
            <a:xfrm flipV="1">
              <a:off x="3222019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Gerade Verbindung 76"/>
            <p:cNvCxnSpPr/>
            <p:nvPr/>
          </p:nvCxnSpPr>
          <p:spPr>
            <a:xfrm flipV="1">
              <a:off x="3915082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Gerade Verbindung 77"/>
            <p:cNvCxnSpPr/>
            <p:nvPr/>
          </p:nvCxnSpPr>
          <p:spPr>
            <a:xfrm flipV="1">
              <a:off x="4608145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Gerade Verbindung 78"/>
            <p:cNvCxnSpPr/>
            <p:nvPr/>
          </p:nvCxnSpPr>
          <p:spPr>
            <a:xfrm flipV="1">
              <a:off x="5301208" y="6199188"/>
              <a:ext cx="0" cy="2116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Textfeld 57"/>
          <p:cNvSpPr txBox="1"/>
          <p:nvPr/>
        </p:nvSpPr>
        <p:spPr>
          <a:xfrm>
            <a:off x="116632" y="262553"/>
            <a:ext cx="1334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de-DE" sz="1200" b="1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7808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Office PowerPoint</Application>
  <PresentationFormat>Bildschirmpräsentation (4:3)</PresentationFormat>
  <Paragraphs>4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ämmerer, Ulrike</dc:creator>
  <cp:lastModifiedBy>Kämmerer, Ulrike</cp:lastModifiedBy>
  <cp:revision>8</cp:revision>
  <cp:lastPrinted>2018-02-21T10:48:10Z</cp:lastPrinted>
  <dcterms:created xsi:type="dcterms:W3CDTF">2018-02-21T10:29:14Z</dcterms:created>
  <dcterms:modified xsi:type="dcterms:W3CDTF">2018-06-05T11:15:55Z</dcterms:modified>
</cp:coreProperties>
</file>